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1228"/>
    <p:restoredTop sz="96327"/>
  </p:normalViewPr>
  <p:slideViewPr>
    <p:cSldViewPr snapToGrid="0">
      <p:cViewPr varScale="1">
        <p:scale>
          <a:sx n="92" d="100"/>
          <a:sy n="92" d="100"/>
        </p:scale>
        <p:origin x="176" y="1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evathi.shan/Desktop/gut%20microbiome%20data-netrial-1-2021/MicrobiomeSummary_BarPlo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Abundance of Main Genera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943661344268467"/>
          <c:y val="7.9951570569807812E-2"/>
          <c:w val="0.81125867602649848"/>
          <c:h val="0.56421126113543663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Genera!$OV$138</c:f>
              <c:strCache>
                <c:ptCount val="1"/>
                <c:pt idx="0">
                  <c:v>Other Gener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38:$PB$138</c:f>
              <c:numCache>
                <c:formatCode>General</c:formatCode>
                <c:ptCount val="6"/>
                <c:pt idx="0">
                  <c:v>19.715674230500014</c:v>
                </c:pt>
                <c:pt idx="1">
                  <c:v>24.93597680137502</c:v>
                </c:pt>
                <c:pt idx="2">
                  <c:v>22.981252838875008</c:v>
                </c:pt>
                <c:pt idx="3">
                  <c:v>27.412070178499988</c:v>
                </c:pt>
                <c:pt idx="4">
                  <c:v>23.436989214375004</c:v>
                </c:pt>
                <c:pt idx="5">
                  <c:v>26.9954817143749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C42-A840-A0C0-0320E246A6DB}"/>
            </c:ext>
          </c:extLst>
        </c:ser>
        <c:ser>
          <c:idx val="1"/>
          <c:order val="1"/>
          <c:tx>
            <c:strRef>
              <c:f>Genera!$OV$139</c:f>
              <c:strCache>
                <c:ptCount val="1"/>
                <c:pt idx="0">
                  <c:v>Faecalibacterium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39:$PB$139</c:f>
              <c:numCache>
                <c:formatCode>General</c:formatCode>
                <c:ptCount val="6"/>
                <c:pt idx="0">
                  <c:v>22.084008173375</c:v>
                </c:pt>
                <c:pt idx="1">
                  <c:v>7.9947858678750006</c:v>
                </c:pt>
                <c:pt idx="2">
                  <c:v>23.369531896125</c:v>
                </c:pt>
                <c:pt idx="3">
                  <c:v>22.660243883500002</c:v>
                </c:pt>
                <c:pt idx="4">
                  <c:v>23.735583257624999</c:v>
                </c:pt>
                <c:pt idx="5">
                  <c:v>19.2868681063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C42-A840-A0C0-0320E246A6DB}"/>
            </c:ext>
          </c:extLst>
        </c:ser>
        <c:ser>
          <c:idx val="2"/>
          <c:order val="2"/>
          <c:tx>
            <c:strRef>
              <c:f>Genera!$OV$140</c:f>
              <c:strCache>
                <c:ptCount val="1"/>
                <c:pt idx="0">
                  <c:v>[Ruminococcus]_torques_group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40:$PB$140</c:f>
              <c:numCache>
                <c:formatCode>General</c:formatCode>
                <c:ptCount val="6"/>
                <c:pt idx="0">
                  <c:v>12.025729880125001</c:v>
                </c:pt>
                <c:pt idx="1">
                  <c:v>17.566943562624999</c:v>
                </c:pt>
                <c:pt idx="2">
                  <c:v>13.977698478749998</c:v>
                </c:pt>
                <c:pt idx="3">
                  <c:v>14.246084408249999</c:v>
                </c:pt>
                <c:pt idx="4">
                  <c:v>11.016913685875</c:v>
                </c:pt>
                <c:pt idx="5">
                  <c:v>12.669063632875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C42-A840-A0C0-0320E246A6DB}"/>
            </c:ext>
          </c:extLst>
        </c:ser>
        <c:ser>
          <c:idx val="3"/>
          <c:order val="3"/>
          <c:tx>
            <c:strRef>
              <c:f>Genera!$OV$141</c:f>
              <c:strCache>
                <c:ptCount val="1"/>
                <c:pt idx="0">
                  <c:v>Lactobacillus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41:$PB$141</c:f>
              <c:numCache>
                <c:formatCode>General</c:formatCode>
                <c:ptCount val="6"/>
                <c:pt idx="0">
                  <c:v>10.244551683999999</c:v>
                </c:pt>
                <c:pt idx="1">
                  <c:v>8.8884876471250003</c:v>
                </c:pt>
                <c:pt idx="2">
                  <c:v>3.0908775732500002</c:v>
                </c:pt>
                <c:pt idx="3">
                  <c:v>3.2969943426250001</c:v>
                </c:pt>
                <c:pt idx="4">
                  <c:v>11.058985712249999</c:v>
                </c:pt>
                <c:pt idx="5">
                  <c:v>4.276805910374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C42-A840-A0C0-0320E246A6DB}"/>
            </c:ext>
          </c:extLst>
        </c:ser>
        <c:ser>
          <c:idx val="4"/>
          <c:order val="4"/>
          <c:tx>
            <c:strRef>
              <c:f>Genera!$OV$142</c:f>
              <c:strCache>
                <c:ptCount val="1"/>
                <c:pt idx="0">
                  <c:v>Clostridia_UCG-014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42:$PB$142</c:f>
              <c:numCache>
                <c:formatCode>General</c:formatCode>
                <c:ptCount val="6"/>
                <c:pt idx="0">
                  <c:v>3.587430247625</c:v>
                </c:pt>
                <c:pt idx="1">
                  <c:v>4.8446572048750003</c:v>
                </c:pt>
                <c:pt idx="2">
                  <c:v>6.1478533953749999</c:v>
                </c:pt>
                <c:pt idx="3">
                  <c:v>5.0881492359999996</c:v>
                </c:pt>
                <c:pt idx="4">
                  <c:v>4.9506659691249997</c:v>
                </c:pt>
                <c:pt idx="5">
                  <c:v>7.70383011400000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C42-A840-A0C0-0320E246A6DB}"/>
            </c:ext>
          </c:extLst>
        </c:ser>
        <c:ser>
          <c:idx val="5"/>
          <c:order val="5"/>
          <c:tx>
            <c:strRef>
              <c:f>Genera!$OV$143</c:f>
              <c:strCache>
                <c:ptCount val="1"/>
                <c:pt idx="0">
                  <c:v>Butyricicoccus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43:$PB$143</c:f>
              <c:numCache>
                <c:formatCode>General</c:formatCode>
                <c:ptCount val="6"/>
                <c:pt idx="0">
                  <c:v>7.9740401532499998</c:v>
                </c:pt>
                <c:pt idx="1">
                  <c:v>4.7574677468749993</c:v>
                </c:pt>
                <c:pt idx="2">
                  <c:v>2.792858614125</c:v>
                </c:pt>
                <c:pt idx="3">
                  <c:v>3.8894149054999994</c:v>
                </c:pt>
                <c:pt idx="4">
                  <c:v>2.3905239258750002</c:v>
                </c:pt>
                <c:pt idx="5">
                  <c:v>2.9372319106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FC42-A840-A0C0-0320E246A6DB}"/>
            </c:ext>
          </c:extLst>
        </c:ser>
        <c:ser>
          <c:idx val="6"/>
          <c:order val="6"/>
          <c:tx>
            <c:strRef>
              <c:f>Genera!$OV$144</c:f>
              <c:strCache>
                <c:ptCount val="1"/>
                <c:pt idx="0">
                  <c:v>Subdoligranulum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44:$PB$144</c:f>
              <c:numCache>
                <c:formatCode>General</c:formatCode>
                <c:ptCount val="6"/>
                <c:pt idx="0">
                  <c:v>3.305878087</c:v>
                </c:pt>
                <c:pt idx="1">
                  <c:v>9.1526369586249992</c:v>
                </c:pt>
                <c:pt idx="2">
                  <c:v>2.751024475625</c:v>
                </c:pt>
                <c:pt idx="3">
                  <c:v>3.7558784146250002</c:v>
                </c:pt>
                <c:pt idx="4">
                  <c:v>1.9929339404999999</c:v>
                </c:pt>
                <c:pt idx="5">
                  <c:v>3.22269857175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FC42-A840-A0C0-0320E246A6DB}"/>
            </c:ext>
          </c:extLst>
        </c:ser>
        <c:ser>
          <c:idx val="7"/>
          <c:order val="7"/>
          <c:tx>
            <c:strRef>
              <c:f>Genera!$OV$145</c:f>
              <c:strCache>
                <c:ptCount val="1"/>
                <c:pt idx="0">
                  <c:v>Alistipes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45:$PB$145</c:f>
              <c:numCache>
                <c:formatCode>General</c:formatCode>
                <c:ptCount val="6"/>
                <c:pt idx="0">
                  <c:v>0.72838863862499992</c:v>
                </c:pt>
                <c:pt idx="1">
                  <c:v>0.72318686924999986</c:v>
                </c:pt>
                <c:pt idx="2">
                  <c:v>1.5656837596250002</c:v>
                </c:pt>
                <c:pt idx="3">
                  <c:v>0.45192136687500001</c:v>
                </c:pt>
                <c:pt idx="4">
                  <c:v>4.8673931692500005</c:v>
                </c:pt>
                <c:pt idx="5">
                  <c:v>6.52261570924999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FC42-A840-A0C0-0320E246A6DB}"/>
            </c:ext>
          </c:extLst>
        </c:ser>
        <c:ser>
          <c:idx val="8"/>
          <c:order val="8"/>
          <c:tx>
            <c:strRef>
              <c:f>Genera!$OV$146</c:f>
              <c:strCache>
                <c:ptCount val="1"/>
                <c:pt idx="0">
                  <c:v>Blautia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46:$PB$146</c:f>
              <c:numCache>
                <c:formatCode>General</c:formatCode>
                <c:ptCount val="6"/>
                <c:pt idx="0">
                  <c:v>0.58522423112499999</c:v>
                </c:pt>
                <c:pt idx="1">
                  <c:v>4.0572453543749996</c:v>
                </c:pt>
                <c:pt idx="2">
                  <c:v>1.3104024883750001</c:v>
                </c:pt>
                <c:pt idx="3">
                  <c:v>2.7934384994999997</c:v>
                </c:pt>
                <c:pt idx="4">
                  <c:v>2.3224792993750003</c:v>
                </c:pt>
                <c:pt idx="5">
                  <c:v>2.07379547574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FC42-A840-A0C0-0320E246A6DB}"/>
            </c:ext>
          </c:extLst>
        </c:ser>
        <c:ser>
          <c:idx val="9"/>
          <c:order val="9"/>
          <c:tx>
            <c:strRef>
              <c:f>Genera!$OV$147</c:f>
              <c:strCache>
                <c:ptCount val="1"/>
                <c:pt idx="0">
                  <c:v>Sellimonas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47:$PB$147</c:f>
              <c:numCache>
                <c:formatCode>General</c:formatCode>
                <c:ptCount val="6"/>
                <c:pt idx="0">
                  <c:v>1.7277729342500003</c:v>
                </c:pt>
                <c:pt idx="1">
                  <c:v>3.0886628621250001</c:v>
                </c:pt>
                <c:pt idx="2">
                  <c:v>1.6299709511250002</c:v>
                </c:pt>
                <c:pt idx="3">
                  <c:v>1.8214078947499999</c:v>
                </c:pt>
                <c:pt idx="4">
                  <c:v>2.1109752847500003</c:v>
                </c:pt>
                <c:pt idx="5">
                  <c:v>1.8271784756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FC42-A840-A0C0-0320E246A6DB}"/>
            </c:ext>
          </c:extLst>
        </c:ser>
        <c:ser>
          <c:idx val="10"/>
          <c:order val="10"/>
          <c:tx>
            <c:strRef>
              <c:f>Genera!$OV$148</c:f>
              <c:strCache>
                <c:ptCount val="1"/>
                <c:pt idx="0">
                  <c:v>Erysipelatoclostridium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48:$PB$148</c:f>
              <c:numCache>
                <c:formatCode>General</c:formatCode>
                <c:ptCount val="6"/>
                <c:pt idx="0">
                  <c:v>1.23901955425</c:v>
                </c:pt>
                <c:pt idx="1">
                  <c:v>1.9433734289999998</c:v>
                </c:pt>
                <c:pt idx="2">
                  <c:v>1.785653829625</c:v>
                </c:pt>
                <c:pt idx="3">
                  <c:v>1.8956933644999998</c:v>
                </c:pt>
                <c:pt idx="4">
                  <c:v>1.3806146385</c:v>
                </c:pt>
                <c:pt idx="5">
                  <c:v>2.082068095124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FC42-A840-A0C0-0320E246A6DB}"/>
            </c:ext>
          </c:extLst>
        </c:ser>
        <c:ser>
          <c:idx val="11"/>
          <c:order val="11"/>
          <c:tx>
            <c:strRef>
              <c:f>Genera!$OV$149</c:f>
              <c:strCache>
                <c:ptCount val="1"/>
                <c:pt idx="0">
                  <c:v>Fournierella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49:$PB$149</c:f>
              <c:numCache>
                <c:formatCode>General</c:formatCode>
                <c:ptCount val="6"/>
                <c:pt idx="0">
                  <c:v>3.014036650125</c:v>
                </c:pt>
                <c:pt idx="1">
                  <c:v>1.62297860875</c:v>
                </c:pt>
                <c:pt idx="2">
                  <c:v>3.1250274686250004</c:v>
                </c:pt>
                <c:pt idx="3">
                  <c:v>0.98187411962500004</c:v>
                </c:pt>
                <c:pt idx="4">
                  <c:v>0.485345912125</c:v>
                </c:pt>
                <c:pt idx="5">
                  <c:v>0.18261902075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FC42-A840-A0C0-0320E246A6DB}"/>
            </c:ext>
          </c:extLst>
        </c:ser>
        <c:ser>
          <c:idx val="12"/>
          <c:order val="12"/>
          <c:tx>
            <c:strRef>
              <c:f>Genera!$OV$150</c:f>
              <c:strCache>
                <c:ptCount val="1"/>
                <c:pt idx="0">
                  <c:v>Incertae_Sedis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50:$PB$150</c:f>
              <c:numCache>
                <c:formatCode>General</c:formatCode>
                <c:ptCount val="6"/>
                <c:pt idx="0">
                  <c:v>1.259002123875</c:v>
                </c:pt>
                <c:pt idx="1">
                  <c:v>1.8988911178749999</c:v>
                </c:pt>
                <c:pt idx="2">
                  <c:v>0.96544394087500007</c:v>
                </c:pt>
                <c:pt idx="3">
                  <c:v>1.57429711175</c:v>
                </c:pt>
                <c:pt idx="4">
                  <c:v>1.4306288814999999</c:v>
                </c:pt>
                <c:pt idx="5">
                  <c:v>1.65668174625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FC42-A840-A0C0-0320E246A6DB}"/>
            </c:ext>
          </c:extLst>
        </c:ser>
        <c:ser>
          <c:idx val="13"/>
          <c:order val="13"/>
          <c:tx>
            <c:strRef>
              <c:f>Genera!$OV$151</c:f>
              <c:strCache>
                <c:ptCount val="1"/>
                <c:pt idx="0">
                  <c:v>[Eubacterium]_coprostanoligenes_group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51:$PB$151</c:f>
              <c:numCache>
                <c:formatCode>General</c:formatCode>
                <c:ptCount val="6"/>
                <c:pt idx="0">
                  <c:v>1.1816213496250001</c:v>
                </c:pt>
                <c:pt idx="1">
                  <c:v>1.372682123625</c:v>
                </c:pt>
                <c:pt idx="2">
                  <c:v>1.840094296875</c:v>
                </c:pt>
                <c:pt idx="3">
                  <c:v>1.5617578426249998</c:v>
                </c:pt>
                <c:pt idx="4">
                  <c:v>0.98646472237499994</c:v>
                </c:pt>
                <c:pt idx="5">
                  <c:v>1.394427464875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FC42-A840-A0C0-0320E246A6DB}"/>
            </c:ext>
          </c:extLst>
        </c:ser>
        <c:ser>
          <c:idx val="14"/>
          <c:order val="14"/>
          <c:tx>
            <c:strRef>
              <c:f>Genera!$OV$152</c:f>
              <c:strCache>
                <c:ptCount val="1"/>
                <c:pt idx="0">
                  <c:v>UCG-005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52:$PB$152</c:f>
              <c:numCache>
                <c:formatCode>General</c:formatCode>
                <c:ptCount val="6"/>
                <c:pt idx="0">
                  <c:v>0.89524842137500016</c:v>
                </c:pt>
                <c:pt idx="1">
                  <c:v>0.7106203204999999</c:v>
                </c:pt>
                <c:pt idx="2">
                  <c:v>3.5128355572499999</c:v>
                </c:pt>
                <c:pt idx="3">
                  <c:v>1.07381177475</c:v>
                </c:pt>
                <c:pt idx="4">
                  <c:v>1.529770637625</c:v>
                </c:pt>
                <c:pt idx="5">
                  <c:v>0.545355697875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FC42-A840-A0C0-0320E246A6DB}"/>
            </c:ext>
          </c:extLst>
        </c:ser>
        <c:ser>
          <c:idx val="15"/>
          <c:order val="15"/>
          <c:tx>
            <c:strRef>
              <c:f>Genera!$OV$153</c:f>
              <c:strCache>
                <c:ptCount val="1"/>
                <c:pt idx="0">
                  <c:v>Bacteroides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53:$PB$153</c:f>
              <c:numCache>
                <c:formatCode>General</c:formatCode>
                <c:ptCount val="6"/>
                <c:pt idx="0">
                  <c:v>1.77015715325</c:v>
                </c:pt>
                <c:pt idx="1">
                  <c:v>1.630277724875</c:v>
                </c:pt>
                <c:pt idx="2">
                  <c:v>1.84085159875</c:v>
                </c:pt>
                <c:pt idx="3">
                  <c:v>1.265136431375</c:v>
                </c:pt>
                <c:pt idx="4">
                  <c:v>1.1624744064999999</c:v>
                </c:pt>
                <c:pt idx="5">
                  <c:v>0.435809695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FC42-A840-A0C0-0320E246A6DB}"/>
            </c:ext>
          </c:extLst>
        </c:ser>
        <c:ser>
          <c:idx val="16"/>
          <c:order val="16"/>
          <c:tx>
            <c:strRef>
              <c:f>Genera!$OV$154</c:f>
              <c:strCache>
                <c:ptCount val="1"/>
                <c:pt idx="0">
                  <c:v>Lachnoclostridium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54:$PB$154</c:f>
              <c:numCache>
                <c:formatCode>General</c:formatCode>
                <c:ptCount val="6"/>
                <c:pt idx="0">
                  <c:v>1.221808608875</c:v>
                </c:pt>
                <c:pt idx="1">
                  <c:v>0.98552606175000013</c:v>
                </c:pt>
                <c:pt idx="2">
                  <c:v>0.89955364737499999</c:v>
                </c:pt>
                <c:pt idx="3">
                  <c:v>0.97345349324999997</c:v>
                </c:pt>
                <c:pt idx="4">
                  <c:v>0.74948982737500003</c:v>
                </c:pt>
                <c:pt idx="5">
                  <c:v>1.218047378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FC42-A840-A0C0-0320E246A6DB}"/>
            </c:ext>
          </c:extLst>
        </c:ser>
        <c:ser>
          <c:idx val="17"/>
          <c:order val="17"/>
          <c:tx>
            <c:strRef>
              <c:f>Genera!$OV$155</c:f>
              <c:strCache>
                <c:ptCount val="1"/>
                <c:pt idx="0">
                  <c:v>Christensenellaceae_R-7_group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55:$PB$155</c:f>
              <c:numCache>
                <c:formatCode>General</c:formatCode>
                <c:ptCount val="6"/>
                <c:pt idx="0">
                  <c:v>0.39388102525000007</c:v>
                </c:pt>
                <c:pt idx="1">
                  <c:v>1.14004243175</c:v>
                </c:pt>
                <c:pt idx="2">
                  <c:v>0.45348662537500001</c:v>
                </c:pt>
                <c:pt idx="3">
                  <c:v>1.1393057431250002</c:v>
                </c:pt>
                <c:pt idx="4">
                  <c:v>1.188279291375</c:v>
                </c:pt>
                <c:pt idx="5">
                  <c:v>1.53060079924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FC42-A840-A0C0-0320E246A6DB}"/>
            </c:ext>
          </c:extLst>
        </c:ser>
        <c:ser>
          <c:idx val="18"/>
          <c:order val="18"/>
          <c:tx>
            <c:strRef>
              <c:f>Genera!$OV$156</c:f>
              <c:strCache>
                <c:ptCount val="1"/>
                <c:pt idx="0">
                  <c:v>Eisenbergiella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56:$PB$156</c:f>
              <c:numCache>
                <c:formatCode>General</c:formatCode>
                <c:ptCount val="6"/>
                <c:pt idx="0">
                  <c:v>0.92357194787499997</c:v>
                </c:pt>
                <c:pt idx="1">
                  <c:v>0.95944148137500007</c:v>
                </c:pt>
                <c:pt idx="2">
                  <c:v>0.846080707875</c:v>
                </c:pt>
                <c:pt idx="3">
                  <c:v>1.2394688813750001</c:v>
                </c:pt>
                <c:pt idx="4">
                  <c:v>0.57269938062500003</c:v>
                </c:pt>
                <c:pt idx="5">
                  <c:v>0.90210405025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FC42-A840-A0C0-0320E246A6DB}"/>
            </c:ext>
          </c:extLst>
        </c:ser>
        <c:ser>
          <c:idx val="19"/>
          <c:order val="19"/>
          <c:tx>
            <c:strRef>
              <c:f>Genera!$OV$157</c:f>
              <c:strCache>
                <c:ptCount val="1"/>
                <c:pt idx="0">
                  <c:v>Streptococcus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57:$PB$157</c:f>
              <c:numCache>
                <c:formatCode>General</c:formatCode>
                <c:ptCount val="6"/>
                <c:pt idx="0">
                  <c:v>1.7637987038750003</c:v>
                </c:pt>
                <c:pt idx="1">
                  <c:v>0.46272734962500001</c:v>
                </c:pt>
                <c:pt idx="2">
                  <c:v>0.81191366349999994</c:v>
                </c:pt>
                <c:pt idx="3">
                  <c:v>0.617237490625</c:v>
                </c:pt>
                <c:pt idx="4">
                  <c:v>1.0744997487500001</c:v>
                </c:pt>
                <c:pt idx="5">
                  <c:v>0.32458853887499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FC42-A840-A0C0-0320E246A6DB}"/>
            </c:ext>
          </c:extLst>
        </c:ser>
        <c:ser>
          <c:idx val="20"/>
          <c:order val="20"/>
          <c:tx>
            <c:strRef>
              <c:f>Genera!$OV$158</c:f>
              <c:strCache>
                <c:ptCount val="1"/>
                <c:pt idx="0">
                  <c:v>Negativibacillus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58:$PB$158</c:f>
              <c:numCache>
                <c:formatCode>General</c:formatCode>
                <c:ptCount val="6"/>
                <c:pt idx="0">
                  <c:v>0.53794750525000001</c:v>
                </c:pt>
                <c:pt idx="1">
                  <c:v>0.40612660012500001</c:v>
                </c:pt>
                <c:pt idx="2">
                  <c:v>1.0689917841250001</c:v>
                </c:pt>
                <c:pt idx="3">
                  <c:v>1.0449729438749999</c:v>
                </c:pt>
                <c:pt idx="4">
                  <c:v>0.68683921049999996</c:v>
                </c:pt>
                <c:pt idx="5">
                  <c:v>1.168669392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FC42-A840-A0C0-0320E246A6DB}"/>
            </c:ext>
          </c:extLst>
        </c:ser>
        <c:ser>
          <c:idx val="21"/>
          <c:order val="21"/>
          <c:tx>
            <c:strRef>
              <c:f>Genera!$OV$159</c:f>
              <c:strCache>
                <c:ptCount val="1"/>
                <c:pt idx="0">
                  <c:v>Escherichia-Shigella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59:$PB$159</c:f>
              <c:numCache>
                <c:formatCode>General</c:formatCode>
                <c:ptCount val="6"/>
                <c:pt idx="0">
                  <c:v>3.5824477553749996</c:v>
                </c:pt>
                <c:pt idx="1">
                  <c:v>0.36852046849999998</c:v>
                </c:pt>
                <c:pt idx="2">
                  <c:v>0.17828919062499998</c:v>
                </c:pt>
                <c:pt idx="3">
                  <c:v>0.15112060300000002</c:v>
                </c:pt>
                <c:pt idx="4">
                  <c:v>0.16101894200000003</c:v>
                </c:pt>
                <c:pt idx="5">
                  <c:v>6.608181925000000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FC42-A840-A0C0-0320E246A6DB}"/>
            </c:ext>
          </c:extLst>
        </c:ser>
        <c:ser>
          <c:idx val="22"/>
          <c:order val="22"/>
          <c:tx>
            <c:strRef>
              <c:f>Genera!$OV$160</c:f>
              <c:strCache>
                <c:ptCount val="1"/>
                <c:pt idx="0">
                  <c:v>Shuttleworthia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60:$PB$160</c:f>
              <c:numCache>
                <c:formatCode>General</c:formatCode>
                <c:ptCount val="6"/>
                <c:pt idx="0">
                  <c:v>0.237356972625</c:v>
                </c:pt>
                <c:pt idx="1">
                  <c:v>0.48874140712500003</c:v>
                </c:pt>
                <c:pt idx="2">
                  <c:v>0.63743083062500006</c:v>
                </c:pt>
                <c:pt idx="3">
                  <c:v>0.70345127774999994</c:v>
                </c:pt>
                <c:pt idx="4">
                  <c:v>0.65644449299999996</c:v>
                </c:pt>
                <c:pt idx="5">
                  <c:v>0.66188180774999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FC42-A840-A0C0-0320E246A6DB}"/>
            </c:ext>
          </c:extLst>
        </c:ser>
        <c:ser>
          <c:idx val="23"/>
          <c:order val="23"/>
          <c:tx>
            <c:strRef>
              <c:f>Genera!$OV$161</c:f>
              <c:strCache>
                <c:ptCount val="1"/>
                <c:pt idx="0">
                  <c:v>Megamonas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Genera!$OW$137:$PB$137</c:f>
              <c:strCache>
                <c:ptCount val="6"/>
                <c:pt idx="0">
                  <c:v>d21-Ctrl</c:v>
                </c:pt>
                <c:pt idx="1">
                  <c:v>d21-Mycotoxins</c:v>
                </c:pt>
                <c:pt idx="2">
                  <c:v>d28-Ctrl</c:v>
                </c:pt>
                <c:pt idx="3">
                  <c:v>d28-Mycotoxins</c:v>
                </c:pt>
                <c:pt idx="4">
                  <c:v>d35-Ctrl</c:v>
                </c:pt>
                <c:pt idx="5">
                  <c:v>d35-Mycotoxins</c:v>
                </c:pt>
              </c:strCache>
            </c:strRef>
          </c:cat>
          <c:val>
            <c:numRef>
              <c:f>Genera!$OW$161:$PB$161</c:f>
              <c:numCache>
                <c:formatCode>General</c:formatCode>
                <c:ptCount val="6"/>
                <c:pt idx="0">
                  <c:v>1.4039685E-3</c:v>
                </c:pt>
                <c:pt idx="1">
                  <c:v>0</c:v>
                </c:pt>
                <c:pt idx="2">
                  <c:v>2.4171923872500001</c:v>
                </c:pt>
                <c:pt idx="3">
                  <c:v>0.36281579224999994</c:v>
                </c:pt>
                <c:pt idx="4">
                  <c:v>5.1986448749999997E-2</c:v>
                </c:pt>
                <c:pt idx="5">
                  <c:v>0.315494873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FC42-A840-A0C0-0320E246A6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11298415"/>
        <c:axId val="2142472384"/>
      </c:barChart>
      <c:catAx>
        <c:axId val="1129841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142472384"/>
        <c:crosses val="autoZero"/>
        <c:auto val="1"/>
        <c:lblAlgn val="ctr"/>
        <c:lblOffset val="100"/>
        <c:noMultiLvlLbl val="0"/>
      </c:catAx>
      <c:valAx>
        <c:axId val="2142472384"/>
        <c:scaling>
          <c:orientation val="minMax"/>
        </c:scaling>
        <c:delete val="0"/>
        <c:axPos val="l"/>
        <c:numFmt formatCode="0%" sourceLinked="1"/>
        <c:majorTickMark val="none"/>
        <c:minorTickMark val="none"/>
        <c:tickLblPos val="nextTo"/>
        <c:spPr>
          <a:noFill/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29841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6.8821961422252595E-2"/>
          <c:y val="0.69784743036152741"/>
          <c:w val="0.73695603978180169"/>
          <c:h val="0.3021525696384725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041C6A-72D3-6CED-F822-AA6766B8D61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EBF5610-2A20-DD95-914A-1CE785CE213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2F472B-CAC7-1BA4-165A-062A07CA0F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567A3-4524-B34E-AB9B-EEBFFC83C79A}" type="datetimeFigureOut">
              <a:rPr lang="en-US" smtClean="0"/>
              <a:t>11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A5610D-B3CE-344D-6342-F770AAC229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E143DB-E7A2-F56E-D3FF-04B1F1327F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CC0A6C-D994-2D4A-B41F-1C582CCA5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4129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B7E0B3-B24F-8F77-1E00-CBEE6131BB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3BDB91-D6E2-4D53-7055-70EDBE46DB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6179CE-656E-E7CC-B62E-CACBF6F235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567A3-4524-B34E-AB9B-EEBFFC83C79A}" type="datetimeFigureOut">
              <a:rPr lang="en-US" smtClean="0"/>
              <a:t>11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94FB0B-39E3-0C8E-05E0-20DAE4D4D8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ADE5C2-FB00-EF6A-2F20-C298A567F9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CC0A6C-D994-2D4A-B41F-1C582CCA5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509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14CDA92-15DC-BB58-A388-152C6358B6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979F04-6223-4883-37CF-1E482E0CC3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C432FD-3D6D-444E-1D13-7761C87C31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567A3-4524-B34E-AB9B-EEBFFC83C79A}" type="datetimeFigureOut">
              <a:rPr lang="en-US" smtClean="0"/>
              <a:t>11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FAB075-841C-9D75-FF73-303C9C7521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B980D0-7266-6A67-E71F-47E849D889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CC0A6C-D994-2D4A-B41F-1C582CCA5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3365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DCDC01-BFBE-86F0-D547-AFD05B3F86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6A1FCD-C999-4A52-D564-05A397663C5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593809-02AE-7CF1-4CD3-09D5C28D5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567A3-4524-B34E-AB9B-EEBFFC83C79A}" type="datetimeFigureOut">
              <a:rPr lang="en-US" smtClean="0"/>
              <a:t>11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99BD7F-9753-97B5-8DEE-0FC79C6BB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33F16B-F03D-D0E8-7DF4-D1DD922B8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CC0A6C-D994-2D4A-B41F-1C582CCA5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0034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AF3502-586B-3A17-3569-38523019BC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F6F6FF-2CA3-C3A0-2F07-A339E02DF9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8148CB-E4DD-0E34-662E-D3D312AC9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567A3-4524-B34E-AB9B-EEBFFC83C79A}" type="datetimeFigureOut">
              <a:rPr lang="en-US" smtClean="0"/>
              <a:t>11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4A77C3-0A30-18D3-4DAF-38C7D8FA04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56395C-FCC0-26F8-0FF0-F12EEB0EED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CC0A6C-D994-2D4A-B41F-1C582CCA5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7409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537031-CA2A-A8FB-D165-CDAD4E8FF3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A37CB8-8F39-D9B7-7208-2E3E24FF868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9FCFE53-F94C-4945-1A72-705D375366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0F8CEC-E048-8F7F-11DB-BEADACB5D6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567A3-4524-B34E-AB9B-EEBFFC83C79A}" type="datetimeFigureOut">
              <a:rPr lang="en-US" smtClean="0"/>
              <a:t>11/2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59B643-2373-015A-7090-8C156F35B6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50C3E0-FE75-81F5-9059-BAD1DAA2B2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CC0A6C-D994-2D4A-B41F-1C582CCA5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293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D19E85-FB97-FFFA-4B78-E26D241EAB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558FB2-DD1E-1D96-E70F-0BA344E9E1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38A70EF-1AA2-70A0-791E-3496473D3A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50756BB-FB97-BF1D-C790-C3535433351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99B8130-476B-9050-EE0F-1AFCAF6A69F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A89713A-52BC-C441-07EB-494B05E1B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567A3-4524-B34E-AB9B-EEBFFC83C79A}" type="datetimeFigureOut">
              <a:rPr lang="en-US" smtClean="0"/>
              <a:t>11/23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6B0ADB8-6027-E87D-71F2-18E6FFC174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B22E8F6-6AC7-EDCC-CDF7-9C1E3CD97D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CC0A6C-D994-2D4A-B41F-1C582CCA5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7802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D0B810-2490-0B2A-005E-04C058519F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91EC21A-4B5F-BC11-5B9C-C8CF5E0972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567A3-4524-B34E-AB9B-EEBFFC83C79A}" type="datetimeFigureOut">
              <a:rPr lang="en-US" smtClean="0"/>
              <a:t>11/23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C9B7E33-F961-84AE-4396-583C80BEB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5328866-09AF-885A-BCC0-495D7913F7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CC0A6C-D994-2D4A-B41F-1C582CCA5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0681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FEC58DB-64B6-0AB0-4D96-F483DB6759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567A3-4524-B34E-AB9B-EEBFFC83C79A}" type="datetimeFigureOut">
              <a:rPr lang="en-US" smtClean="0"/>
              <a:t>11/23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BF1413F-B482-6AAC-75D1-CE7F815974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4248FA1-4F96-20EE-E86A-C200D80A9A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CC0A6C-D994-2D4A-B41F-1C582CCA5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6425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79E16B-6158-7EFC-072D-3C3605D697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6552CA-097C-BE25-9FF3-18E9D552DA4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92B84A-7A41-4323-57F9-9870043D49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C7C480-4DF1-EF42-77BA-D5D080EE7E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567A3-4524-B34E-AB9B-EEBFFC83C79A}" type="datetimeFigureOut">
              <a:rPr lang="en-US" smtClean="0"/>
              <a:t>11/2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5F4625-37D6-1A23-0F3B-BA3183C473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EF723B-D943-ACEB-6D8E-AE791627F5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CC0A6C-D994-2D4A-B41F-1C582CCA5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75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301A68-3577-983F-EFC3-2350B5C034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81C8D14-2179-9F80-6BBD-8A7C48ADF7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7071653-DDA0-941A-DBE4-4052D8D055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9365CD-17F4-EBDB-9A69-99157E92FE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567A3-4524-B34E-AB9B-EEBFFC83C79A}" type="datetimeFigureOut">
              <a:rPr lang="en-US" smtClean="0"/>
              <a:t>11/2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19ACE1-410A-2B06-8D86-A36EBCC72B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311D14-AF0C-1517-D50F-DC48E940CA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CC0A6C-D994-2D4A-B41F-1C582CCA5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49444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81B8908-9AB6-D73F-17C3-39D6CB1799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8222A4-C7C0-5F13-3DAF-3FABF56267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9C2ABD-BE94-224C-358C-26C36F4FEE1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9567A3-4524-B34E-AB9B-EEBFFC83C79A}" type="datetimeFigureOut">
              <a:rPr lang="en-US" smtClean="0"/>
              <a:t>11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C17BBA-FE17-4C8B-9DAE-C035D81248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8BAD09-A595-C632-2C76-66F657DCE69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CC0A6C-D994-2D4A-B41F-1C582CCA5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7020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6E979A0C-1518-6C43-BDB1-9955A05F57AB}"/>
              </a:ext>
            </a:extLst>
          </p:cNvPr>
          <p:cNvGraphicFramePr>
            <a:graphicFrameLocks/>
          </p:cNvGraphicFramePr>
          <p:nvPr/>
        </p:nvGraphicFramePr>
        <p:xfrm>
          <a:off x="1828801" y="476249"/>
          <a:ext cx="7336970" cy="62075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231217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n, Revathi - ARS</dc:creator>
  <cp:lastModifiedBy>Shan, Revathi - ARS</cp:lastModifiedBy>
  <cp:revision>1</cp:revision>
  <dcterms:created xsi:type="dcterms:W3CDTF">2022-11-23T21:10:59Z</dcterms:created>
  <dcterms:modified xsi:type="dcterms:W3CDTF">2022-11-23T21:12:05Z</dcterms:modified>
</cp:coreProperties>
</file>